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36004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3AEF93-ED7E-434A-841C-7EBD1178B8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59148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2152440"/>
            <a:ext cx="59148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3FA5BF-ADD9-45A6-BCC4-A8EAB67943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95868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215244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215244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C0970C-CFC0-46F4-8161-9FEB7AAF2C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19044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958680"/>
            <a:ext cx="19044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958680"/>
            <a:ext cx="19044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2152440"/>
            <a:ext cx="19044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2152440"/>
            <a:ext cx="19044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2152440"/>
            <a:ext cx="19044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8A4628-ECA2-466C-8717-BB944ED9A5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958680"/>
            <a:ext cx="5914800" cy="2284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524"/>
              </a:spcBef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1C46F5-BB44-45B6-B31C-02D673E317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5914800" cy="22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0F0808-F12B-4CFF-9FE9-DE9B2E357E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2886120" cy="22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958680"/>
            <a:ext cx="2886120" cy="22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BE7ADA-7821-4478-8B87-2A4FA757B5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B26186-E71D-4AD1-B9D2-DBA7B7F252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191880"/>
            <a:ext cx="5914800" cy="3223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524"/>
              </a:spcBef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CEC8B3-68B6-4E5E-918A-4CBF278D89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958680"/>
            <a:ext cx="2886120" cy="22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215244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A56855-FEC4-4A91-8AB3-3D1A5C1B98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2886120" cy="22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95868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215244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9FE3D7-3737-4D2D-B932-E985AC5393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95868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2152440"/>
            <a:ext cx="59148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BE209C-F171-4FE0-A3F3-2E8BF45D3D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958680"/>
            <a:ext cx="5914800" cy="22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1916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1" marL="35892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2" marL="60012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3" marL="83988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4" marL="107964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5" marL="107964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6" marL="107964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3336840"/>
            <a:ext cx="1542960" cy="192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3336840"/>
            <a:ext cx="2314800" cy="192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3336840"/>
            <a:ext cx="1542960" cy="192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6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60DB9F4-3A72-4AF1-9580-27DDA4407629}" type="slidenum">
              <a:rPr b="0" lang="zh-CN" sz="6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3"/>
          <p:cNvGrpSpPr/>
          <p:nvPr/>
        </p:nvGrpSpPr>
        <p:grpSpPr>
          <a:xfrm>
            <a:off x="79200" y="336600"/>
            <a:ext cx="7026480" cy="2698920"/>
            <a:chOff x="79200" y="336600"/>
            <a:chExt cx="7026480" cy="2698920"/>
          </a:xfrm>
        </p:grpSpPr>
        <p:pic>
          <p:nvPicPr>
            <p:cNvPr id="42" name="图片 3" descr="20200920-Layout-1"/>
            <p:cNvPicPr/>
            <p:nvPr/>
          </p:nvPicPr>
          <p:blipFill>
            <a:blip r:embed="rId1"/>
            <a:stretch/>
          </p:blipFill>
          <p:spPr>
            <a:xfrm>
              <a:off x="923040" y="663480"/>
              <a:ext cx="876240" cy="772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图片 5" descr="20200920-Layout-3"/>
            <p:cNvPicPr/>
            <p:nvPr/>
          </p:nvPicPr>
          <p:blipFill>
            <a:blip r:embed="rId2"/>
            <a:stretch/>
          </p:blipFill>
          <p:spPr>
            <a:xfrm>
              <a:off x="3260160" y="623880"/>
              <a:ext cx="876240" cy="814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图片 6" descr="20200920-Layout-7"/>
            <p:cNvPicPr/>
            <p:nvPr/>
          </p:nvPicPr>
          <p:blipFill>
            <a:blip r:embed="rId3"/>
            <a:srcRect l="0" t="4891" r="0" b="0"/>
            <a:stretch/>
          </p:blipFill>
          <p:spPr>
            <a:xfrm>
              <a:off x="923040" y="1800360"/>
              <a:ext cx="877680" cy="736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图片 7" descr="20200920-Layout-9"/>
            <p:cNvPicPr/>
            <p:nvPr/>
          </p:nvPicPr>
          <p:blipFill>
            <a:blip r:embed="rId4"/>
            <a:srcRect l="0" t="2469" r="0" b="0"/>
            <a:stretch/>
          </p:blipFill>
          <p:spPr>
            <a:xfrm>
              <a:off x="2088360" y="1782720"/>
              <a:ext cx="876240" cy="753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图片 9" descr="20200920-Layout-10"/>
            <p:cNvPicPr/>
            <p:nvPr/>
          </p:nvPicPr>
          <p:blipFill>
            <a:blip r:embed="rId5"/>
            <a:srcRect l="0" t="3214" r="0" b="0"/>
            <a:stretch/>
          </p:blipFill>
          <p:spPr>
            <a:xfrm>
              <a:off x="3260160" y="1787400"/>
              <a:ext cx="876240" cy="7491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7" name="组合 27"/>
            <p:cNvGrpSpPr/>
            <p:nvPr/>
          </p:nvGrpSpPr>
          <p:grpSpPr>
            <a:xfrm>
              <a:off x="419760" y="622080"/>
              <a:ext cx="533160" cy="915480"/>
              <a:chOff x="419760" y="622080"/>
              <a:chExt cx="533160" cy="915480"/>
            </a:xfrm>
          </p:grpSpPr>
          <p:sp>
            <p:nvSpPr>
              <p:cNvPr id="48" name="文本框 10"/>
              <p:cNvSpPr/>
              <p:nvPr/>
            </p:nvSpPr>
            <p:spPr>
              <a:xfrm>
                <a:off x="419760" y="1291320"/>
                <a:ext cx="533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文本框 11"/>
              <p:cNvSpPr/>
              <p:nvPr/>
            </p:nvSpPr>
            <p:spPr>
              <a:xfrm>
                <a:off x="479880" y="944280"/>
                <a:ext cx="473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15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文本框 14"/>
              <p:cNvSpPr/>
              <p:nvPr/>
            </p:nvSpPr>
            <p:spPr>
              <a:xfrm>
                <a:off x="479880" y="622080"/>
                <a:ext cx="473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3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1" name="组合 28"/>
            <p:cNvGrpSpPr/>
            <p:nvPr/>
          </p:nvGrpSpPr>
          <p:grpSpPr>
            <a:xfrm>
              <a:off x="797760" y="1376280"/>
              <a:ext cx="1045800" cy="246240"/>
              <a:chOff x="797760" y="1376280"/>
              <a:chExt cx="1045800" cy="246240"/>
            </a:xfrm>
          </p:grpSpPr>
          <p:sp>
            <p:nvSpPr>
              <p:cNvPr id="52" name="文本框 15"/>
              <p:cNvSpPr/>
              <p:nvPr/>
            </p:nvSpPr>
            <p:spPr>
              <a:xfrm>
                <a:off x="797760" y="1376280"/>
                <a:ext cx="321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文本框 17"/>
              <p:cNvSpPr/>
              <p:nvPr/>
            </p:nvSpPr>
            <p:spPr>
              <a:xfrm>
                <a:off x="1051200" y="1376280"/>
                <a:ext cx="472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4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文本框 20"/>
              <p:cNvSpPr/>
              <p:nvPr/>
            </p:nvSpPr>
            <p:spPr>
              <a:xfrm>
                <a:off x="1371240" y="1376280"/>
                <a:ext cx="472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8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55" name="图片 4" descr="20200920-Layout-2"/>
            <p:cNvPicPr/>
            <p:nvPr/>
          </p:nvPicPr>
          <p:blipFill>
            <a:blip r:embed="rId6"/>
            <a:srcRect l="0" t="10361" r="0" b="0"/>
            <a:stretch/>
          </p:blipFill>
          <p:spPr>
            <a:xfrm>
              <a:off x="2088360" y="660240"/>
              <a:ext cx="876240" cy="7617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6" name="组合 34"/>
            <p:cNvGrpSpPr/>
            <p:nvPr/>
          </p:nvGrpSpPr>
          <p:grpSpPr>
            <a:xfrm>
              <a:off x="1639080" y="587160"/>
              <a:ext cx="531720" cy="921600"/>
              <a:chOff x="1639080" y="587160"/>
              <a:chExt cx="531720" cy="921600"/>
            </a:xfrm>
          </p:grpSpPr>
          <p:sp>
            <p:nvSpPr>
              <p:cNvPr id="57" name="文本框 35"/>
              <p:cNvSpPr/>
              <p:nvPr/>
            </p:nvSpPr>
            <p:spPr>
              <a:xfrm>
                <a:off x="1639080" y="1262520"/>
                <a:ext cx="531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文本框 36"/>
              <p:cNvSpPr/>
              <p:nvPr/>
            </p:nvSpPr>
            <p:spPr>
              <a:xfrm>
                <a:off x="1698840" y="919800"/>
                <a:ext cx="471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6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文本框 37"/>
              <p:cNvSpPr/>
              <p:nvPr/>
            </p:nvSpPr>
            <p:spPr>
              <a:xfrm>
                <a:off x="1698840" y="587160"/>
                <a:ext cx="471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12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0" name="组合 40"/>
            <p:cNvGrpSpPr/>
            <p:nvPr/>
          </p:nvGrpSpPr>
          <p:grpSpPr>
            <a:xfrm>
              <a:off x="1980720" y="1376280"/>
              <a:ext cx="1020240" cy="246240"/>
              <a:chOff x="1980720" y="1376280"/>
              <a:chExt cx="1020240" cy="246240"/>
            </a:xfrm>
          </p:grpSpPr>
          <p:sp>
            <p:nvSpPr>
              <p:cNvPr id="61" name="文本框 41"/>
              <p:cNvSpPr/>
              <p:nvPr/>
            </p:nvSpPr>
            <p:spPr>
              <a:xfrm>
                <a:off x="1980720" y="1376280"/>
                <a:ext cx="322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文本框 42"/>
              <p:cNvSpPr/>
              <p:nvPr/>
            </p:nvSpPr>
            <p:spPr>
              <a:xfrm>
                <a:off x="2215440" y="1376280"/>
                <a:ext cx="472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4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文本框 43"/>
              <p:cNvSpPr/>
              <p:nvPr/>
            </p:nvSpPr>
            <p:spPr>
              <a:xfrm>
                <a:off x="2528280" y="1376280"/>
                <a:ext cx="472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8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4" name="组合 48"/>
            <p:cNvGrpSpPr/>
            <p:nvPr/>
          </p:nvGrpSpPr>
          <p:grpSpPr>
            <a:xfrm>
              <a:off x="2812680" y="622080"/>
              <a:ext cx="533160" cy="902520"/>
              <a:chOff x="2812680" y="622080"/>
              <a:chExt cx="533160" cy="902520"/>
            </a:xfrm>
          </p:grpSpPr>
          <p:sp>
            <p:nvSpPr>
              <p:cNvPr id="65" name="文本框 49"/>
              <p:cNvSpPr/>
              <p:nvPr/>
            </p:nvSpPr>
            <p:spPr>
              <a:xfrm>
                <a:off x="2812680" y="1278360"/>
                <a:ext cx="533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文本框 50"/>
              <p:cNvSpPr/>
              <p:nvPr/>
            </p:nvSpPr>
            <p:spPr>
              <a:xfrm>
                <a:off x="2872800" y="945000"/>
                <a:ext cx="473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文本框 51"/>
              <p:cNvSpPr/>
              <p:nvPr/>
            </p:nvSpPr>
            <p:spPr>
              <a:xfrm>
                <a:off x="2872800" y="622080"/>
                <a:ext cx="473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8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8" name="组合 52"/>
            <p:cNvGrpSpPr/>
            <p:nvPr/>
          </p:nvGrpSpPr>
          <p:grpSpPr>
            <a:xfrm>
              <a:off x="3141360" y="1376280"/>
              <a:ext cx="1039320" cy="246240"/>
              <a:chOff x="3141360" y="1376280"/>
              <a:chExt cx="1039320" cy="246240"/>
            </a:xfrm>
          </p:grpSpPr>
          <p:sp>
            <p:nvSpPr>
              <p:cNvPr id="69" name="文本框 53"/>
              <p:cNvSpPr/>
              <p:nvPr/>
            </p:nvSpPr>
            <p:spPr>
              <a:xfrm>
                <a:off x="3141360" y="1376280"/>
                <a:ext cx="322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文本框 54"/>
              <p:cNvSpPr/>
              <p:nvPr/>
            </p:nvSpPr>
            <p:spPr>
              <a:xfrm>
                <a:off x="3388680" y="1376280"/>
                <a:ext cx="472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4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文本框 55"/>
              <p:cNvSpPr/>
              <p:nvPr/>
            </p:nvSpPr>
            <p:spPr>
              <a:xfrm>
                <a:off x="3708000" y="1376280"/>
                <a:ext cx="472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8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2" name="组合 56"/>
            <p:cNvGrpSpPr/>
            <p:nvPr/>
          </p:nvGrpSpPr>
          <p:grpSpPr>
            <a:xfrm>
              <a:off x="419760" y="1698480"/>
              <a:ext cx="533160" cy="915480"/>
              <a:chOff x="419760" y="1698480"/>
              <a:chExt cx="533160" cy="915480"/>
            </a:xfrm>
          </p:grpSpPr>
          <p:sp>
            <p:nvSpPr>
              <p:cNvPr id="73" name="文本框 57"/>
              <p:cNvSpPr/>
              <p:nvPr/>
            </p:nvSpPr>
            <p:spPr>
              <a:xfrm>
                <a:off x="419760" y="2367720"/>
                <a:ext cx="533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文本框 58"/>
              <p:cNvSpPr/>
              <p:nvPr/>
            </p:nvSpPr>
            <p:spPr>
              <a:xfrm>
                <a:off x="479880" y="2027520"/>
                <a:ext cx="473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4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文本框 59"/>
              <p:cNvSpPr/>
              <p:nvPr/>
            </p:nvSpPr>
            <p:spPr>
              <a:xfrm>
                <a:off x="479880" y="1698480"/>
                <a:ext cx="473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8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6" name="组合 60"/>
            <p:cNvGrpSpPr/>
            <p:nvPr/>
          </p:nvGrpSpPr>
          <p:grpSpPr>
            <a:xfrm>
              <a:off x="802440" y="2484360"/>
              <a:ext cx="1044720" cy="246240"/>
              <a:chOff x="802440" y="2484360"/>
              <a:chExt cx="1044720" cy="246240"/>
            </a:xfrm>
          </p:grpSpPr>
          <p:sp>
            <p:nvSpPr>
              <p:cNvPr id="77" name="文本框 61"/>
              <p:cNvSpPr/>
              <p:nvPr/>
            </p:nvSpPr>
            <p:spPr>
              <a:xfrm>
                <a:off x="802440" y="2484360"/>
                <a:ext cx="321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文本框 62"/>
              <p:cNvSpPr/>
              <p:nvPr/>
            </p:nvSpPr>
            <p:spPr>
              <a:xfrm>
                <a:off x="1055520" y="2484360"/>
                <a:ext cx="471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4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文本框 63"/>
              <p:cNvSpPr/>
              <p:nvPr/>
            </p:nvSpPr>
            <p:spPr>
              <a:xfrm>
                <a:off x="1375200" y="2484360"/>
                <a:ext cx="471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8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0" name="组合 64"/>
            <p:cNvGrpSpPr/>
            <p:nvPr/>
          </p:nvGrpSpPr>
          <p:grpSpPr>
            <a:xfrm>
              <a:off x="3139560" y="2484360"/>
              <a:ext cx="1044360" cy="246240"/>
              <a:chOff x="3139560" y="2484360"/>
              <a:chExt cx="1044360" cy="246240"/>
            </a:xfrm>
          </p:grpSpPr>
          <p:sp>
            <p:nvSpPr>
              <p:cNvPr id="81" name="文本框 65"/>
              <p:cNvSpPr/>
              <p:nvPr/>
            </p:nvSpPr>
            <p:spPr>
              <a:xfrm>
                <a:off x="3139560" y="2484360"/>
                <a:ext cx="321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文本框 66"/>
              <p:cNvSpPr/>
              <p:nvPr/>
            </p:nvSpPr>
            <p:spPr>
              <a:xfrm>
                <a:off x="3393000" y="2484360"/>
                <a:ext cx="471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4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文本框 67"/>
              <p:cNvSpPr/>
              <p:nvPr/>
            </p:nvSpPr>
            <p:spPr>
              <a:xfrm>
                <a:off x="3711960" y="2484360"/>
                <a:ext cx="471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8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4" name="组合 68"/>
            <p:cNvGrpSpPr/>
            <p:nvPr/>
          </p:nvGrpSpPr>
          <p:grpSpPr>
            <a:xfrm>
              <a:off x="1956600" y="2484360"/>
              <a:ext cx="1045800" cy="246240"/>
              <a:chOff x="1956600" y="2484360"/>
              <a:chExt cx="1045800" cy="246240"/>
            </a:xfrm>
          </p:grpSpPr>
          <p:sp>
            <p:nvSpPr>
              <p:cNvPr id="85" name="文本框 69"/>
              <p:cNvSpPr/>
              <p:nvPr/>
            </p:nvSpPr>
            <p:spPr>
              <a:xfrm>
                <a:off x="1956600" y="2484360"/>
                <a:ext cx="321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文本框 70"/>
              <p:cNvSpPr/>
              <p:nvPr/>
            </p:nvSpPr>
            <p:spPr>
              <a:xfrm>
                <a:off x="2210040" y="2484360"/>
                <a:ext cx="472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4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文本框 71"/>
              <p:cNvSpPr/>
              <p:nvPr/>
            </p:nvSpPr>
            <p:spPr>
              <a:xfrm>
                <a:off x="2530080" y="2484360"/>
                <a:ext cx="472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8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8" name="组合 72"/>
            <p:cNvGrpSpPr/>
            <p:nvPr/>
          </p:nvGrpSpPr>
          <p:grpSpPr>
            <a:xfrm>
              <a:off x="1639080" y="1695240"/>
              <a:ext cx="531720" cy="937800"/>
              <a:chOff x="1639080" y="1695240"/>
              <a:chExt cx="531720" cy="937800"/>
            </a:xfrm>
          </p:grpSpPr>
          <p:sp>
            <p:nvSpPr>
              <p:cNvPr id="89" name="文本框 73"/>
              <p:cNvSpPr/>
              <p:nvPr/>
            </p:nvSpPr>
            <p:spPr>
              <a:xfrm>
                <a:off x="1639080" y="2386800"/>
                <a:ext cx="531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文本框 74"/>
              <p:cNvSpPr/>
              <p:nvPr/>
            </p:nvSpPr>
            <p:spPr>
              <a:xfrm>
                <a:off x="1698840" y="2035080"/>
                <a:ext cx="471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3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文本框 75"/>
              <p:cNvSpPr/>
              <p:nvPr/>
            </p:nvSpPr>
            <p:spPr>
              <a:xfrm>
                <a:off x="1698840" y="1695240"/>
                <a:ext cx="471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6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2" name="组合 76"/>
            <p:cNvGrpSpPr/>
            <p:nvPr/>
          </p:nvGrpSpPr>
          <p:grpSpPr>
            <a:xfrm>
              <a:off x="2812680" y="1670040"/>
              <a:ext cx="533160" cy="964800"/>
              <a:chOff x="2812680" y="1670040"/>
              <a:chExt cx="533160" cy="964800"/>
            </a:xfrm>
          </p:grpSpPr>
          <p:sp>
            <p:nvSpPr>
              <p:cNvPr id="93" name="文本框 77"/>
              <p:cNvSpPr/>
              <p:nvPr/>
            </p:nvSpPr>
            <p:spPr>
              <a:xfrm>
                <a:off x="2812680" y="2388600"/>
                <a:ext cx="533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文本框 78"/>
              <p:cNvSpPr/>
              <p:nvPr/>
            </p:nvSpPr>
            <p:spPr>
              <a:xfrm>
                <a:off x="2872800" y="2023200"/>
                <a:ext cx="473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3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文本框 79"/>
              <p:cNvSpPr/>
              <p:nvPr/>
            </p:nvSpPr>
            <p:spPr>
              <a:xfrm>
                <a:off x="2872800" y="1670040"/>
                <a:ext cx="473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6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96" name="文本框 80"/>
            <p:cNvSpPr/>
            <p:nvPr/>
          </p:nvSpPr>
          <p:spPr>
            <a:xfrm>
              <a:off x="1164600" y="587160"/>
              <a:ext cx="873000" cy="39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1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:52.14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:21.61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2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M:26.25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文本框 82"/>
            <p:cNvSpPr/>
            <p:nvPr/>
          </p:nvSpPr>
          <p:spPr>
            <a:xfrm>
              <a:off x="2329920" y="587160"/>
              <a:ext cx="873000" cy="39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1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:55.04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:21.89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2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M:23.07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文本框 83"/>
            <p:cNvSpPr/>
            <p:nvPr/>
          </p:nvSpPr>
          <p:spPr>
            <a:xfrm>
              <a:off x="3504960" y="587160"/>
              <a:ext cx="874800" cy="39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1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:54.02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:20.73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2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M:25.25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文本框 84"/>
            <p:cNvSpPr/>
            <p:nvPr/>
          </p:nvSpPr>
          <p:spPr>
            <a:xfrm>
              <a:off x="1164600" y="1762200"/>
              <a:ext cx="873000" cy="39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1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:67.88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:21.51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2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M:10.61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文本框 85"/>
            <p:cNvSpPr/>
            <p:nvPr/>
          </p:nvSpPr>
          <p:spPr>
            <a:xfrm>
              <a:off x="2329920" y="1762200"/>
              <a:ext cx="873000" cy="39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1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:69.09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:20.06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2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M:10.85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文本框 86"/>
            <p:cNvSpPr/>
            <p:nvPr/>
          </p:nvSpPr>
          <p:spPr>
            <a:xfrm>
              <a:off x="3504960" y="1762200"/>
              <a:ext cx="874800" cy="39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0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1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:69.30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:19.88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Arial"/>
                  <a:ea typeface="宋体"/>
                </a:rPr>
                <a:t>2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M:10.82%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文本框 200"/>
            <p:cNvSpPr/>
            <p:nvPr/>
          </p:nvSpPr>
          <p:spPr>
            <a:xfrm>
              <a:off x="1131120" y="34452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tr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文本框 201"/>
            <p:cNvSpPr/>
            <p:nvPr/>
          </p:nvSpPr>
          <p:spPr>
            <a:xfrm>
              <a:off x="2309400" y="344520"/>
              <a:ext cx="60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文本框 202"/>
            <p:cNvSpPr/>
            <p:nvPr/>
          </p:nvSpPr>
          <p:spPr>
            <a:xfrm>
              <a:off x="3423960" y="344520"/>
              <a:ext cx="652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atrin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05" name="组合 119"/>
            <p:cNvGrpSpPr/>
            <p:nvPr/>
          </p:nvGrpSpPr>
          <p:grpSpPr>
            <a:xfrm>
              <a:off x="4265280" y="336600"/>
              <a:ext cx="1944360" cy="1327680"/>
              <a:chOff x="4265280" y="336600"/>
              <a:chExt cx="1944360" cy="1327680"/>
            </a:xfrm>
          </p:grpSpPr>
          <p:pic>
            <p:nvPicPr>
              <p:cNvPr id="106" name="图片 94" descr="E:\重庆医科大学附属儿童医院\何老师课题\SCI撰写\SCI撰写20200909\SK-N-AS().tifSK-N-AS()"/>
              <p:cNvPicPr/>
              <p:nvPr/>
            </p:nvPicPr>
            <p:blipFill>
              <a:blip r:embed="rId7"/>
              <a:stretch/>
            </p:blipFill>
            <p:spPr>
              <a:xfrm>
                <a:off x="4748400" y="431640"/>
                <a:ext cx="1344960" cy="100620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07" name="组合 102"/>
              <p:cNvGrpSpPr/>
              <p:nvPr/>
            </p:nvGrpSpPr>
            <p:grpSpPr>
              <a:xfrm>
                <a:off x="4747680" y="1418040"/>
                <a:ext cx="1461960" cy="246240"/>
                <a:chOff x="4747680" y="1418040"/>
                <a:chExt cx="1461960" cy="246240"/>
              </a:xfrm>
            </p:grpSpPr>
            <p:sp>
              <p:nvSpPr>
                <p:cNvPr id="108" name="文本框 200"/>
                <p:cNvSpPr/>
                <p:nvPr/>
              </p:nvSpPr>
              <p:spPr>
                <a:xfrm>
                  <a:off x="4747680" y="1418040"/>
                  <a:ext cx="522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宋体"/>
                    </a:rPr>
                    <a:t>Ctrl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9" name="文本框 201"/>
                <p:cNvSpPr/>
                <p:nvPr/>
              </p:nvSpPr>
              <p:spPr>
                <a:xfrm>
                  <a:off x="5144760" y="1418040"/>
                  <a:ext cx="6008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宋体"/>
                    </a:rPr>
                    <a:t>DMSO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0" name="文本框 202"/>
                <p:cNvSpPr/>
                <p:nvPr/>
              </p:nvSpPr>
              <p:spPr>
                <a:xfrm>
                  <a:off x="5558040" y="1418040"/>
                  <a:ext cx="651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宋体"/>
                    </a:rPr>
                    <a:t>Matrine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11" name="文本框 99"/>
              <p:cNvSpPr/>
              <p:nvPr/>
            </p:nvSpPr>
            <p:spPr>
              <a:xfrm rot="10800000">
                <a:off x="4265280" y="465840"/>
                <a:ext cx="332640" cy="936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% Cell cycle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文本框 103"/>
              <p:cNvSpPr/>
              <p:nvPr/>
            </p:nvSpPr>
            <p:spPr>
              <a:xfrm>
                <a:off x="4366800" y="336600"/>
                <a:ext cx="437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文本框 104"/>
              <p:cNvSpPr/>
              <p:nvPr/>
            </p:nvSpPr>
            <p:spPr>
              <a:xfrm>
                <a:off x="4366800" y="1279800"/>
                <a:ext cx="437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文本框 105"/>
              <p:cNvSpPr/>
              <p:nvPr/>
            </p:nvSpPr>
            <p:spPr>
              <a:xfrm>
                <a:off x="4366800" y="572400"/>
                <a:ext cx="437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7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文本框 106"/>
              <p:cNvSpPr/>
              <p:nvPr/>
            </p:nvSpPr>
            <p:spPr>
              <a:xfrm>
                <a:off x="4366800" y="808200"/>
                <a:ext cx="437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文本框 107"/>
              <p:cNvSpPr/>
              <p:nvPr/>
            </p:nvSpPr>
            <p:spPr>
              <a:xfrm>
                <a:off x="4366800" y="1044000"/>
                <a:ext cx="437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2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7" name="组合 118"/>
            <p:cNvGrpSpPr/>
            <p:nvPr/>
          </p:nvGrpSpPr>
          <p:grpSpPr>
            <a:xfrm>
              <a:off x="4265640" y="1511280"/>
              <a:ext cx="1946160" cy="1309320"/>
              <a:chOff x="4265640" y="1511280"/>
              <a:chExt cx="1946160" cy="1309320"/>
            </a:xfrm>
          </p:grpSpPr>
          <p:pic>
            <p:nvPicPr>
              <p:cNvPr id="118" name="图片 95" descr="E:\重庆医科大学附属儿童医院\何老师课题\SCI撰写\SCI撰写20200909\SK-N-DZ().tifSK-N-DZ()"/>
              <p:cNvPicPr/>
              <p:nvPr/>
            </p:nvPicPr>
            <p:blipFill>
              <a:blip r:embed="rId8"/>
              <a:stretch/>
            </p:blipFill>
            <p:spPr>
              <a:xfrm>
                <a:off x="4748040" y="1613880"/>
                <a:ext cx="1346400" cy="1006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9" name="文本框 100"/>
              <p:cNvSpPr/>
              <p:nvPr/>
            </p:nvSpPr>
            <p:spPr>
              <a:xfrm rot="10800000">
                <a:off x="4265640" y="1550520"/>
                <a:ext cx="332640" cy="937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% Cell cycle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20" name="组合 108"/>
              <p:cNvGrpSpPr/>
              <p:nvPr/>
            </p:nvGrpSpPr>
            <p:grpSpPr>
              <a:xfrm>
                <a:off x="4748760" y="2574360"/>
                <a:ext cx="1463040" cy="246240"/>
                <a:chOff x="4748760" y="2574360"/>
                <a:chExt cx="1463040" cy="246240"/>
              </a:xfrm>
            </p:grpSpPr>
            <p:sp>
              <p:nvSpPr>
                <p:cNvPr id="121" name="文本框 200"/>
                <p:cNvSpPr/>
                <p:nvPr/>
              </p:nvSpPr>
              <p:spPr>
                <a:xfrm>
                  <a:off x="4748760" y="2574360"/>
                  <a:ext cx="523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宋体"/>
                    </a:rPr>
                    <a:t>Ctrl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" name="文本框 201"/>
                <p:cNvSpPr/>
                <p:nvPr/>
              </p:nvSpPr>
              <p:spPr>
                <a:xfrm>
                  <a:off x="5146200" y="2574360"/>
                  <a:ext cx="6012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宋体"/>
                    </a:rPr>
                    <a:t>DMSO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3" name="文本框 202"/>
                <p:cNvSpPr/>
                <p:nvPr/>
              </p:nvSpPr>
              <p:spPr>
                <a:xfrm>
                  <a:off x="5559840" y="2574360"/>
                  <a:ext cx="6519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宋体"/>
                    </a:rPr>
                    <a:t>Matrine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24" name="文本框 112"/>
              <p:cNvSpPr/>
              <p:nvPr/>
            </p:nvSpPr>
            <p:spPr>
              <a:xfrm>
                <a:off x="4367160" y="1511280"/>
                <a:ext cx="438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文本框 113"/>
              <p:cNvSpPr/>
              <p:nvPr/>
            </p:nvSpPr>
            <p:spPr>
              <a:xfrm>
                <a:off x="4367160" y="2462400"/>
                <a:ext cx="438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文本框 114"/>
              <p:cNvSpPr/>
              <p:nvPr/>
            </p:nvSpPr>
            <p:spPr>
              <a:xfrm>
                <a:off x="4367160" y="1748880"/>
                <a:ext cx="438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7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文本框 115"/>
              <p:cNvSpPr/>
              <p:nvPr/>
            </p:nvSpPr>
            <p:spPr>
              <a:xfrm>
                <a:off x="4367160" y="1986840"/>
                <a:ext cx="438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文本框 116"/>
              <p:cNvSpPr/>
              <p:nvPr/>
            </p:nvSpPr>
            <p:spPr>
              <a:xfrm>
                <a:off x="4367160" y="2224800"/>
                <a:ext cx="438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2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9" name="组合 32"/>
            <p:cNvGrpSpPr/>
            <p:nvPr/>
          </p:nvGrpSpPr>
          <p:grpSpPr>
            <a:xfrm>
              <a:off x="6062760" y="411120"/>
              <a:ext cx="1042920" cy="628200"/>
              <a:chOff x="6062760" y="411120"/>
              <a:chExt cx="1042920" cy="628200"/>
            </a:xfrm>
          </p:grpSpPr>
          <p:sp>
            <p:nvSpPr>
              <p:cNvPr id="130" name="矩形 130"/>
              <p:cNvSpPr/>
              <p:nvPr/>
            </p:nvSpPr>
            <p:spPr>
              <a:xfrm>
                <a:off x="6062760" y="459720"/>
                <a:ext cx="179640" cy="1098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文本框 13"/>
              <p:cNvSpPr/>
              <p:nvPr/>
            </p:nvSpPr>
            <p:spPr>
              <a:xfrm>
                <a:off x="6293160" y="411120"/>
                <a:ext cx="812520" cy="267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G</a:t>
                </a:r>
                <a:r>
                  <a:rPr b="1" lang="en-US" sz="1000" spc="-1" strike="noStrike" baseline="-25000">
                    <a:solidFill>
                      <a:srgbClr val="000000"/>
                    </a:solidFill>
                    <a:latin typeface="Arial"/>
                    <a:ea typeface="宋体"/>
                  </a:rPr>
                  <a:t>0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-G</a:t>
                </a:r>
                <a:r>
                  <a:rPr b="1" lang="en-US" sz="1000" spc="-1" strike="noStrike" baseline="-25000">
                    <a:solidFill>
                      <a:srgbClr val="000000"/>
                    </a:solidFill>
                    <a:latin typeface="Arial"/>
                    <a:ea typeface="宋体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矩形 132"/>
              <p:cNvSpPr/>
              <p:nvPr/>
            </p:nvSpPr>
            <p:spPr>
              <a:xfrm>
                <a:off x="6062760" y="642600"/>
                <a:ext cx="180720" cy="108000"/>
              </a:xfrm>
              <a:prstGeom prst="rect">
                <a:avLst/>
              </a:prstGeom>
              <a:solidFill>
                <a:srgbClr val="e0e0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文本框 19"/>
              <p:cNvSpPr/>
              <p:nvPr/>
            </p:nvSpPr>
            <p:spPr>
              <a:xfrm>
                <a:off x="6293160" y="591840"/>
                <a:ext cx="811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S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矩形 134"/>
              <p:cNvSpPr/>
              <p:nvPr/>
            </p:nvSpPr>
            <p:spPr>
              <a:xfrm>
                <a:off x="6062760" y="821880"/>
                <a:ext cx="180720" cy="109800"/>
              </a:xfrm>
              <a:prstGeom prst="rect">
                <a:avLst/>
              </a:prstGeom>
              <a:solidFill>
                <a:srgbClr val="ff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文本框 22"/>
              <p:cNvSpPr/>
              <p:nvPr/>
            </p:nvSpPr>
            <p:spPr>
              <a:xfrm>
                <a:off x="6293160" y="772200"/>
                <a:ext cx="811800" cy="267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G</a:t>
                </a:r>
                <a:r>
                  <a:rPr b="1" lang="en-US" sz="1000" spc="-1" strike="noStrike" baseline="-25000">
                    <a:solidFill>
                      <a:srgbClr val="000000"/>
                    </a:solidFill>
                    <a:latin typeface="Arial"/>
                    <a:ea typeface="宋体"/>
                  </a:rPr>
                  <a:t>2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-M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36" name="文本框 3"/>
            <p:cNvSpPr/>
            <p:nvPr/>
          </p:nvSpPr>
          <p:spPr>
            <a:xfrm rot="10800000">
              <a:off x="79200" y="689040"/>
              <a:ext cx="332640" cy="72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K-N-A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文本框 4"/>
            <p:cNvSpPr/>
            <p:nvPr/>
          </p:nvSpPr>
          <p:spPr>
            <a:xfrm rot="10800000">
              <a:off x="90000" y="1806480"/>
              <a:ext cx="332640" cy="72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K-N-DZ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38" name="直接箭头连接符 1"/>
            <p:cNvCxnSpPr/>
            <p:nvPr/>
          </p:nvCxnSpPr>
          <p:spPr>
            <a:xfrm flipH="1" flipV="1">
              <a:off x="560880" y="388080"/>
              <a:ext cx="10080" cy="23929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39" name="直接箭头连接符 2"/>
            <p:cNvCxnSpPr/>
            <p:nvPr/>
          </p:nvCxnSpPr>
          <p:spPr>
            <a:xfrm>
              <a:off x="570240" y="2774520"/>
              <a:ext cx="361260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40" name="文本框 3"/>
            <p:cNvSpPr/>
            <p:nvPr/>
          </p:nvSpPr>
          <p:spPr>
            <a:xfrm rot="10800000">
              <a:off x="226800" y="1224000"/>
              <a:ext cx="332640" cy="72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ount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文本框 5"/>
            <p:cNvSpPr/>
            <p:nvPr/>
          </p:nvSpPr>
          <p:spPr>
            <a:xfrm>
              <a:off x="1756800" y="2789280"/>
              <a:ext cx="1239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BV421-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6-19T02:08:00Z</dcterms:created>
  <dc:creator>Administrator</dc:creator>
  <dc:description/>
  <dc:language>en-US</dc:language>
  <cp:lastModifiedBy>He</cp:lastModifiedBy>
  <dcterms:modified xsi:type="dcterms:W3CDTF">2022-05-30T08:57:57Z</dcterms:modified>
  <cp:revision>209</cp:revision>
  <dc:subject/>
  <dc:title>空白演示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25D0280576B43D8B01C905897903AD3</vt:lpwstr>
  </property>
  <property fmtid="{D5CDD505-2E9C-101B-9397-08002B2CF9AE}" pid="3" name="KSOProductBuildVer">
    <vt:lpwstr>2052-11.1.0.10578</vt:lpwstr>
  </property>
</Properties>
</file>